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22A6D3-04D1-45E5-8ED6-669DB23DE28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11D070-96A6-403B-A910-3934508349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7AB8F-F6B5-4184-A800-F9C4258B243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8F3066-93B5-4A41-9AA4-31E78F52DA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79619C-ACBB-41D9-87B3-DE08513170E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48B271-4D45-446C-9067-E05162E0B88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7D5623-BA7C-4675-8BD8-B8CCA134687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6E25D4-C28F-4307-9720-18FE4D642E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933820-1D17-469F-87EC-BB13D1B899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EF9F05-3E32-46F7-A16D-97E9B5B9B6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0333C-0FB8-4919-B164-AF17A51F53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2C0A1F-A399-4421-ABA8-0BDB4E2AABC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4FB2F40-678F-489D-9477-C5EF8AD3E37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rostokąt 3"/>
          <p:cNvSpPr/>
          <p:nvPr/>
        </p:nvSpPr>
        <p:spPr>
          <a:xfrm>
            <a:off x="476280" y="344520"/>
            <a:ext cx="5761080" cy="763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1</a:t>
            </a:r>
            <a:r>
              <a:rPr b="0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he mean GC content of genes is shown for four species as indicated. Coding GC, mean GC content of gene coding sequences; GC1, mean GC content in the 1st positions of codons; GC2, in 2nd positions of codons; GC3, in 3rd positions of codons. The data are from the Codon Usage Database, http://www.kazusa.or.jp/codon/</a:t>
            </a:r>
            <a:r>
              <a:rPr b="0" lang="pl-PL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2" name="Picture 2" descr=""/>
          <p:cNvPicPr/>
          <p:nvPr/>
        </p:nvPicPr>
        <p:blipFill>
          <a:blip r:embed="rId1"/>
          <a:stretch/>
        </p:blipFill>
        <p:spPr>
          <a:xfrm>
            <a:off x="620640" y="1639800"/>
            <a:ext cx="4633920" cy="2895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8T13:37:24Z</dcterms:created>
  <dc:creator>Agnieszka Sirko</dc:creator>
  <dc:description/>
  <dc:language>en-US</dc:language>
  <cp:lastModifiedBy>Agnieszka Sirko</cp:lastModifiedBy>
  <dcterms:modified xsi:type="dcterms:W3CDTF">2016-07-28T13:43:36Z</dcterms:modified>
  <cp:revision>1</cp:revision>
  <dc:subject/>
  <dc:title>Prezentacja programu PowerPoint</dc:title>
</cp:coreProperties>
</file>